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5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36CC37-5917-03C4-A7E1-1AD26C2E17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ACEF3D3-5E66-AD91-6DFE-29EAE8CF75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9A92ED-C287-2223-1694-48C306446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391CF-8145-4C9E-9C8C-35A319149F55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EF2BBD8-2F85-8ECF-7F5B-09AF9489E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B2B613-60EA-4900-04A6-6E667B73D6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35FE9-05DF-4E11-9973-A1BA4DCC4A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1265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A6F93D-E900-7858-1BD3-ED2E89EE2E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F73EA2F-2037-8035-FFF6-9610A2A0D4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B1BD65-AC5A-2168-37E9-20532922A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391CF-8145-4C9E-9C8C-35A319149F55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3EF3510-E397-B058-D510-C48F61A3A0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763614C-DFC9-E2D8-E3AB-832EF20D2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35FE9-05DF-4E11-9973-A1BA4DCC4A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1156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B8495D6-ED86-FD2F-95F4-AE3DE9BA10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098D642-F9AC-F0EE-151D-E28D1951EE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BB41D6-0CCE-6A9B-6656-5EDA746470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391CF-8145-4C9E-9C8C-35A319149F55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ECD0EF-F6C3-26C0-EAA0-5BC119B367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F2157E-C0BF-59D4-E8C0-96E7A29DB7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35FE9-05DF-4E11-9973-A1BA4DCC4A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4318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3C393D-68E1-8DEA-0D3C-EDB50CBC13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DBC723-2F65-87A3-EDDA-91818BF09D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A30344-B058-C8E2-6AA6-8EA844273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391CF-8145-4C9E-9C8C-35A319149F55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0BABD55-CE8B-386A-998C-8EAE5BAD7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AC20F13-3546-80B2-0978-F9A76DEF2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35FE9-05DF-4E11-9973-A1BA4DCC4A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6721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5185B0-A86F-9626-CCAB-2A6BBF2F69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569D201-B629-0F6E-E45E-ACA2FEF524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412EBB-E098-43EC-B483-5A208B0FD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391CF-8145-4C9E-9C8C-35A319149F55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635C67-26F4-18F9-09AD-25D339F6E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70FCF7-C996-36D0-95F5-EF4B9840C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35FE9-05DF-4E11-9973-A1BA4DCC4A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8362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C710D5-A30D-E07B-19CE-4366457B2E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2855F50-679A-6A1B-049E-39D9C3E0C7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27CD9D3-FAC3-7A53-3807-F7856A1B0E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D24575A-5355-024E-6BD2-02988B179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391CF-8145-4C9E-9C8C-35A319149F55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59EDAE0-0073-4399-6CC4-595A39DC8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A02D6BE-C648-5600-57A2-ED534050A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35FE9-05DF-4E11-9973-A1BA4DCC4A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2526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B10F75-03ED-C824-9651-D40D1A4BB4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3D06502-5272-3EF2-68BC-661C775B78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F314264-5983-2FB1-A313-8DDE8EEA2A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F6C5884-355E-13C4-AB7C-7B8BCA3079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E59C132-0688-8B91-0A61-E0B1F37E97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89352D6-13CA-F5C8-E56C-3306386287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391CF-8145-4C9E-9C8C-35A319149F55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B9F9F9D-BAE9-F854-E8E0-C44C88854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253C5E6-BC32-97AF-6836-1543EF9019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35FE9-05DF-4E11-9973-A1BA4DCC4A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93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E2B76B-F6C6-254E-A489-3E88634BEA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724362F-369C-781F-E979-58E63C5B2D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391CF-8145-4C9E-9C8C-35A319149F55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60C943D-D151-4ADF-1406-9B152FF670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91BE359-CC3C-14DC-C5B0-AEED84F839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35FE9-05DF-4E11-9973-A1BA4DCC4A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9755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E6C28DC-1955-2B81-D9CF-822D03C7C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391CF-8145-4C9E-9C8C-35A319149F55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74DED11-FBB5-2682-868A-C7412E93A6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80DDABC-6ECA-E3C4-CBEE-6C71CD4C2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35FE9-05DF-4E11-9973-A1BA4DCC4A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1353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10AF79-7665-89AA-3373-EC441D5D0F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29E9596-4783-4731-4CD4-A9CD52DC11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D8E8B38-3438-894A-8F04-DD4A431B40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B8C4B82-8AF7-FCAA-3CF1-B7C13B9A7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391CF-8145-4C9E-9C8C-35A319149F55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C1D7A53-BD6B-613A-90B7-F4640880E8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67F9EFE-FF20-3F8E-0570-5A33F452DC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35FE9-05DF-4E11-9973-A1BA4DCC4A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085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768753-5CD3-5BF5-A572-A087113B4F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ED35FA2-62A8-FDFB-6080-5217B0A12C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D8C4194-8DA6-322D-D9C0-528015D9B4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C851A16-24A9-B0AF-4800-C4DE93006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391CF-8145-4C9E-9C8C-35A319149F55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643EAEE-8DDC-54AB-CF9A-A3AD38F95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DBAF351-6CAB-BC74-5B27-D73CC3221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35FE9-05DF-4E11-9973-A1BA4DCC4A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8420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B399944-0E3A-AF0A-22AA-CC3D23CD3B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7256CBE-F572-2234-9623-E9DD66E016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4132FF-1B3C-7E1A-1D0A-B0C3AD0E4D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7391CF-8145-4C9E-9C8C-35A319149F55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4625B4-DF92-6655-4A71-D4E1E5C556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3DEBA0-C0C6-DD29-734D-43AA3FB108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A35FE9-05DF-4E11-9973-A1BA4DCC4A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5755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>
            <a:extLst>
              <a:ext uri="{FF2B5EF4-FFF2-40B4-BE49-F238E27FC236}">
                <a16:creationId xmlns:a16="http://schemas.microsoft.com/office/drawing/2014/main" id="{C46D5136-ECC7-B74B-E03F-D82C6DEADF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4125" y="608982"/>
            <a:ext cx="7870829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2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S1</a:t>
            </a:r>
            <a:r>
              <a:rPr kumimoji="0" lang="en-US" altLang="zh-CN" sz="2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B</a:t>
            </a:r>
            <a:r>
              <a:rPr kumimoji="0" lang="en-US" altLang="zh-CN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seline characteristics of participants pre- and post-match</a:t>
            </a:r>
            <a:r>
              <a:rPr kumimoji="0" lang="en-US" altLang="zh-CN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endParaRPr kumimoji="0" lang="en-US" altLang="zh-CN" sz="2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2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aphicFrame>
        <p:nvGraphicFramePr>
          <p:cNvPr id="8" name="表格 7">
            <a:extLst>
              <a:ext uri="{FF2B5EF4-FFF2-40B4-BE49-F238E27FC236}">
                <a16:creationId xmlns:a16="http://schemas.microsoft.com/office/drawing/2014/main" id="{206FA4E9-9604-F0BF-5980-D3AEF7290E1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19494"/>
              </p:ext>
            </p:extLst>
          </p:nvPr>
        </p:nvGraphicFramePr>
        <p:xfrm>
          <a:off x="904125" y="1356360"/>
          <a:ext cx="9857167" cy="4145280"/>
        </p:xfrm>
        <a:graphic>
          <a:graphicData uri="http://schemas.openxmlformats.org/drawingml/2006/table">
            <a:tbl>
              <a:tblPr firstRow="1" firstCol="1" bandRow="1"/>
              <a:tblGrid>
                <a:gridCol w="1834085">
                  <a:extLst>
                    <a:ext uri="{9D8B030D-6E8A-4147-A177-3AD203B41FA5}">
                      <a16:colId xmlns:a16="http://schemas.microsoft.com/office/drawing/2014/main" val="2009316384"/>
                    </a:ext>
                  </a:extLst>
                </a:gridCol>
                <a:gridCol w="1583983">
                  <a:extLst>
                    <a:ext uri="{9D8B030D-6E8A-4147-A177-3AD203B41FA5}">
                      <a16:colId xmlns:a16="http://schemas.microsoft.com/office/drawing/2014/main" val="686285999"/>
                    </a:ext>
                  </a:extLst>
                </a:gridCol>
                <a:gridCol w="1646509">
                  <a:extLst>
                    <a:ext uri="{9D8B030D-6E8A-4147-A177-3AD203B41FA5}">
                      <a16:colId xmlns:a16="http://schemas.microsoft.com/office/drawing/2014/main" val="1759624256"/>
                    </a:ext>
                  </a:extLst>
                </a:gridCol>
                <a:gridCol w="771150">
                  <a:extLst>
                    <a:ext uri="{9D8B030D-6E8A-4147-A177-3AD203B41FA5}">
                      <a16:colId xmlns:a16="http://schemas.microsoft.com/office/drawing/2014/main" val="2997626371"/>
                    </a:ext>
                  </a:extLst>
                </a:gridCol>
                <a:gridCol w="1646509">
                  <a:extLst>
                    <a:ext uri="{9D8B030D-6E8A-4147-A177-3AD203B41FA5}">
                      <a16:colId xmlns:a16="http://schemas.microsoft.com/office/drawing/2014/main" val="1997047291"/>
                    </a:ext>
                  </a:extLst>
                </a:gridCol>
                <a:gridCol w="1563140">
                  <a:extLst>
                    <a:ext uri="{9D8B030D-6E8A-4147-A177-3AD203B41FA5}">
                      <a16:colId xmlns:a16="http://schemas.microsoft.com/office/drawing/2014/main" val="533778480"/>
                    </a:ext>
                  </a:extLst>
                </a:gridCol>
                <a:gridCol w="811791">
                  <a:extLst>
                    <a:ext uri="{9D8B030D-6E8A-4147-A177-3AD203B41FA5}">
                      <a16:colId xmlns:a16="http://schemas.microsoft.com/office/drawing/2014/main" val="2860430624"/>
                    </a:ext>
                  </a:extLst>
                </a:gridCol>
              </a:tblGrid>
              <a:tr h="177800">
                <a:tc rowSpan="2"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haracteristic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81280" indent="-81280"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nmatched patients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81280" indent="-81280"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MD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81280" indent="-81280"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PS Matched Patients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MD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84067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81280" indent="-81280"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β-bloker nonuse</a:t>
                      </a:r>
                      <a:b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(n=267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β-bloker use</a:t>
                      </a:r>
                      <a:b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(n=341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β-bloker nonuse</a:t>
                      </a:r>
                      <a:b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(n=219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β-bloker use</a:t>
                      </a:r>
                      <a:b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(n=219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9637225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F history no.(%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1 (22.8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5 (22.0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0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9 (22.4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3 (24.2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43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760791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EI/ARB no.(%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5 (28.1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5 (48.4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427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1 (32.4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7 (35.2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8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970481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platelet no.(%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5 (28.1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8 (25.8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1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9 (26.9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8 (26.5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10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699300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moking no.(%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0 (22.5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 (20.5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47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1 (23.3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 (21.5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44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369748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M no.(%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4 (24.0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7 (28.4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02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9 (26.9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2 (23.7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74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499012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HD no.(%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7 (10.1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2 ( 9.4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5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 ( 9.1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4 (11.0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61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794565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e (years</a:t>
                      </a:r>
                      <a:r>
                        <a:rPr lang="zh-CN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）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6.2 ± 15.9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9.8 ± 15.7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406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3.5 ± 15.6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3.4 ± 15.3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2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814746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BP (mmHg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2.4 ± 14.1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4.6 ± 14.5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53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3.9 ± 13.7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3.9 ± 13.9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3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613735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BP (mmHg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6.6 ± 22.3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1.2± 20.8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16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6 ± 21.7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6± 19.1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46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655051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V(dL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.5 ± 5.3</a:t>
                      </a:r>
                      <a:endParaRPr lang="zh-CN" sz="1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9 ± 5.1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19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.3 ± 5.3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9 ± 5.1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78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991496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I (scores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.4 ± 2.7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.0 ± 3.5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26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.1 ± 2.8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.0 ± 2.6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49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966353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×P (mg</a:t>
                      </a:r>
                      <a:r>
                        <a:rPr lang="en-US" sz="160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dl</a:t>
                      </a:r>
                      <a:r>
                        <a:rPr lang="en-US" sz="160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6.0 ± 16.4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0.0 ± 17.1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35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.6 ± 16.2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.5 ± 16.0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4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02388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LB (g/L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0.2 ± 7.3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0.8 ± 8.4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72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0.4 ± 7.4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0.4 ± 9.2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&lt;0.001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493190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b (g/L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6.2 ± 20.7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6.8 ± 19.4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31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6.7 ± 20.8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7.32 (20.29)</a:t>
                      </a:r>
                      <a:endParaRPr lang="zh-CN" sz="1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1280" indent="-81280" algn="just"/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33</a:t>
                      </a:r>
                      <a:endParaRPr lang="zh-CN" sz="1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9621446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F4C3334F-9090-EB25-C052-CC18C37AE208}"/>
              </a:ext>
            </a:extLst>
          </p:cNvPr>
          <p:cNvSpPr txBox="1"/>
          <p:nvPr/>
        </p:nvSpPr>
        <p:spPr>
          <a:xfrm>
            <a:off x="632827" y="5710734"/>
            <a:ext cx="1086787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/>
              <a:t>Abbreviations: HF: Heart Failure; SBP: Systolic blood pressure; DBP: Diastolic blood pressure; DM</a:t>
            </a:r>
            <a:r>
              <a:rPr lang="zh-CN" altLang="en-US" sz="1200" dirty="0"/>
              <a:t>：</a:t>
            </a:r>
            <a:r>
              <a:rPr lang="en-US" altLang="zh-CN" sz="1200" dirty="0"/>
              <a:t>Diabetes</a:t>
            </a:r>
            <a:r>
              <a:rPr lang="zh-CN" altLang="en-US" sz="1200" dirty="0"/>
              <a:t>；</a:t>
            </a:r>
            <a:r>
              <a:rPr lang="en-US" altLang="zh-CN" sz="1200" dirty="0"/>
              <a:t>CCI: </a:t>
            </a:r>
            <a:r>
              <a:rPr lang="en-US" altLang="zh-CN" sz="1200" dirty="0" err="1"/>
              <a:t>Charlson</a:t>
            </a:r>
            <a:r>
              <a:rPr lang="en-US" altLang="zh-CN" sz="1200" dirty="0"/>
              <a:t> comorbidities index; CHD: coronary heart disease; UV: urine volume; </a:t>
            </a:r>
            <a:r>
              <a:rPr lang="en-US" altLang="zh-CN" sz="1200" dirty="0" err="1"/>
              <a:t>Ca×P</a:t>
            </a:r>
            <a:r>
              <a:rPr lang="en-US" altLang="zh-CN" sz="1200" dirty="0"/>
              <a:t>: Calcium-phosphorus product;  ACEI: Angiotensin-Converting Enzyme Inhibitor; ARB: Angiotensin II Receptor Blocker; Hb Hemoglobin</a:t>
            </a:r>
            <a:r>
              <a:rPr lang="zh-CN" altLang="en-US" sz="1200" dirty="0"/>
              <a:t>；</a:t>
            </a:r>
            <a:r>
              <a:rPr lang="en-US" altLang="zh-CN" sz="1200" dirty="0"/>
              <a:t>ALB albumin</a:t>
            </a:r>
            <a:r>
              <a:rPr lang="zh-CN" altLang="en-US" sz="1200" dirty="0"/>
              <a:t>；</a:t>
            </a:r>
            <a:endParaRPr lang="en-US" altLang="zh-CN" sz="1200" dirty="0"/>
          </a:p>
        </p:txBody>
      </p:sp>
    </p:spTree>
    <p:extLst>
      <p:ext uri="{BB962C8B-B14F-4D97-AF65-F5344CB8AC3E}">
        <p14:creationId xmlns:p14="http://schemas.microsoft.com/office/powerpoint/2010/main" val="19549088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D4156055-161D-3137-3D12-B7519FAEEF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5497" y="205865"/>
            <a:ext cx="5749070" cy="574907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49466659-0400-D837-92E3-D5209637D184}"/>
              </a:ext>
            </a:extLst>
          </p:cNvPr>
          <p:cNvSpPr txBox="1"/>
          <p:nvPr/>
        </p:nvSpPr>
        <p:spPr>
          <a:xfrm>
            <a:off x="3207224" y="6129195"/>
            <a:ext cx="70149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ROC curves of propensity score matching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89352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8763CB2C-25BD-6F09-7116-E63C9E272B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2612" y="714756"/>
            <a:ext cx="5446776" cy="5428488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E389F70C-02C2-4C67-AEC3-8E796E05E38C}"/>
              </a:ext>
            </a:extLst>
          </p:cNvPr>
          <p:cNvSpPr txBox="1"/>
          <p:nvPr/>
        </p:nvSpPr>
        <p:spPr>
          <a:xfrm>
            <a:off x="1842448" y="6143244"/>
            <a:ext cx="9130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2000" b="0" i="0">
                <a:effectLst/>
                <a:latin typeface="Times New Roman" panose="02020603050405020304" pitchFamily="18" charset="0"/>
              </a:rPr>
              <a:t>SMD </a:t>
            </a:r>
            <a:r>
              <a:rPr lang="en-US" altLang="zh-CN" sz="2000">
                <a:latin typeface="Times New Roman" panose="02020603050405020304" pitchFamily="18" charset="0"/>
              </a:rPr>
              <a:t>plots of propensity score matching for different models</a:t>
            </a:r>
            <a:endParaRPr lang="zh-CN" altLang="en-US" sz="200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409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421</Words>
  <Application>Microsoft Office PowerPoint</Application>
  <PresentationFormat>宽屏</PresentationFormat>
  <Paragraphs>111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美珠 高</dc:creator>
  <cp:lastModifiedBy>Miao Lin</cp:lastModifiedBy>
  <cp:revision>2</cp:revision>
  <dcterms:created xsi:type="dcterms:W3CDTF">2024-01-01T01:54:16Z</dcterms:created>
  <dcterms:modified xsi:type="dcterms:W3CDTF">2024-01-16T20:16:18Z</dcterms:modified>
</cp:coreProperties>
</file>